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80" d="100"/>
          <a:sy n="80" d="100"/>
        </p:scale>
        <p:origin x="-1190" y="-11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17638" y="835025"/>
            <a:ext cx="6592887" cy="3757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2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4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Rectangle 1"/>
          <p:cNvSpPr>
            <a:spLocks noChangeArrowheads="1"/>
          </p:cNvSpPr>
          <p:nvPr/>
        </p:nvSpPr>
        <p:spPr bwMode="auto">
          <a:xfrm>
            <a:off x="971236" y="5058313"/>
            <a:ext cx="7999261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. S4.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Twi1 in vitro activity assay with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2,4,6-trihydroxy-benzoic acid (2,4,6-THBA)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s the sugar acceptor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IR chromatograms of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m/z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=169 [M-H]</a:t>
            </a:r>
            <a:r>
              <a:rPr lang="en-GB" sz="1200" baseline="30000" dirty="0" smtClean="0">
                <a:latin typeface="Arial" pitchFamily="34" charset="0"/>
                <a:cs typeface="Arial" pitchFamily="34" charset="0"/>
              </a:rPr>
              <a:t>-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and 331 [M-H]</a:t>
            </a:r>
            <a:r>
              <a:rPr lang="en-GB" sz="1200" baseline="30000" dirty="0" smtClean="0">
                <a:latin typeface="Arial" pitchFamily="34" charset="0"/>
                <a:cs typeface="Arial" pitchFamily="34" charset="0"/>
              </a:rPr>
              <a:t>-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corresponding to 2,4,6-THBA an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glucosylate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2,4,6-THBA, respectively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Left panel shows the chromatographic peak obtained when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2,4,6-THB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as incubated with UDP-glucose in the presence of the Control sample (protein extract from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N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benthamiana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leaves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groinoculat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ith the pGWB8 empty vector). Right panel corresponds to the chromatogram obtained upon incubation with the Twi1 purified recombinant protein expressed in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N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benthamiana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groinoculat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leaves. The differential peak was detected, corresponding to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2,4,6-THB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njugated with glucose. Samples wer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nalys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y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UPLC-Q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o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MS.</a:t>
            </a:r>
            <a:endParaRPr kumimoji="0" lang="en-GB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122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odrig</dc:creator>
  <cp:lastModifiedBy>irodrig</cp:lastModifiedBy>
  <cp:revision>35</cp:revision>
  <dcterms:created xsi:type="dcterms:W3CDTF">2019-09-04T15:42:00Z</dcterms:created>
  <dcterms:modified xsi:type="dcterms:W3CDTF">2019-09-18T09:14:59Z</dcterms:modified>
</cp:coreProperties>
</file>